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7" r:id="rId2"/>
  </p:sldIdLst>
  <p:sldSz cx="6858000" cy="9144000" type="screen4x3"/>
  <p:notesSz cx="6797675" cy="9926638"/>
  <p:defaultTextStyle>
    <a:defPPr>
      <a:defRPr lang="en-AU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92" userDrawn="1">
          <p15:clr>
            <a:srgbClr val="A4A3A4"/>
          </p15:clr>
        </p15:guide>
        <p15:guide id="2" pos="61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082" autoAdjust="0"/>
    <p:restoredTop sz="95332" autoAdjust="0"/>
  </p:normalViewPr>
  <p:slideViewPr>
    <p:cSldViewPr snapToGrid="0" showGuides="1">
      <p:cViewPr varScale="1">
        <p:scale>
          <a:sx n="66" d="100"/>
          <a:sy n="66" d="100"/>
        </p:scale>
        <p:origin x="2933" y="58"/>
      </p:cViewPr>
      <p:guideLst>
        <p:guide orient="horz" pos="3492"/>
        <p:guide pos="61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466DFD-1D01-46B0-99D4-7752715C965A}" type="datetimeFigureOut">
              <a:rPr lang="en-AU" smtClean="0"/>
              <a:t>30/10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71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871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039207-2A76-4BA9-9A52-13724CD8AF3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9898452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DD717D-9932-4A07-A6DE-333CD40ED279}" type="datetimeFigureOut">
              <a:rPr lang="en-AU" smtClean="0"/>
              <a:t>30/10/2020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0805E6-A15E-4820-9543-010104295D1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112358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7013"/>
            <a:ext cx="5143500" cy="318293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188"/>
            <a:ext cx="5143500" cy="220821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7999F16-BBFC-4758-9715-BA4F54367DD6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179624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78B14B4-FFF2-4984-824D-E6316144EFAB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3513222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4B26BC9-1754-4D92-8F55-86D53E042BA1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462701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C6C781A-8F8C-470E-BCFA-7CAF2C9528D9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78161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8313" y="2279650"/>
            <a:ext cx="5915025" cy="380365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8313" y="6119813"/>
            <a:ext cx="5915025" cy="2000250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95238BB-B4A5-4433-ABBE-091F4D599273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190254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C9F43C1-46BE-4E56-A1DF-5DD79BF46FF9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15495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075" y="487363"/>
            <a:ext cx="5915025" cy="176688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3075" y="2241550"/>
            <a:ext cx="2900363" cy="10985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3075" y="3340100"/>
            <a:ext cx="2900363" cy="491331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0"/>
            <a:ext cx="2916237" cy="10985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6237" cy="491331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D5FD93E-75EE-434B-B31D-885821BA5F5A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0709469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FB3966B-BE84-4591-802D-CE8CF2EF74CF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13810609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D6F5F80-D43C-4140-9477-CCC13E2EBA70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1812626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075" y="609600"/>
            <a:ext cx="221138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6238" y="1316038"/>
            <a:ext cx="3471862" cy="64992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3075" y="2743200"/>
            <a:ext cx="2211388" cy="508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37F84CC-3C95-474D-AE0E-4C9320E2181C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9888047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075" y="609600"/>
            <a:ext cx="221138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6238" y="1316038"/>
            <a:ext cx="3471862" cy="64992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3075" y="2743200"/>
            <a:ext cx="2211388" cy="508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770E0DB-4C24-4196-A9E4-ED5BCB016747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1939221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 smtClean="0"/>
              <a:t>Click to edit Master text styles</a:t>
            </a:r>
          </a:p>
          <a:p>
            <a:pPr lvl="1"/>
            <a:r>
              <a:rPr lang="en-AU" altLang="en-US" smtClean="0"/>
              <a:t>Second level</a:t>
            </a:r>
          </a:p>
          <a:p>
            <a:pPr lvl="2"/>
            <a:r>
              <a:rPr lang="en-AU" altLang="en-US" smtClean="0"/>
              <a:t>Third level</a:t>
            </a:r>
          </a:p>
          <a:p>
            <a:pPr lvl="3"/>
            <a:r>
              <a:rPr lang="en-AU" altLang="en-US" smtClean="0"/>
              <a:t>Fourth level</a:t>
            </a:r>
          </a:p>
          <a:p>
            <a:pPr lvl="4"/>
            <a:r>
              <a:rPr lang="en-AU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AU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AU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6AF1F741-95FE-47FB-A53E-DF0ABCAECF23}" type="slidenum">
              <a:rPr lang="en-AU" altLang="en-US"/>
              <a:pPr/>
              <a:t>‹#›</a:t>
            </a:fld>
            <a:endParaRPr lang="en-AU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TextBox 68"/>
          <p:cNvSpPr txBox="1"/>
          <p:nvPr/>
        </p:nvSpPr>
        <p:spPr>
          <a:xfrm>
            <a:off x="907459" y="5451159"/>
            <a:ext cx="536448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AU" sz="1200" b="1" dirty="0">
                <a:latin typeface="Times New Roman" panose="02020603050405020304" pitchFamily="18" charset="0"/>
                <a:ea typeface="MS Mincho"/>
              </a:rPr>
              <a:t>Supplementary Figure S2: 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Effect of PTH and rhSCL treatment on </a:t>
            </a:r>
            <a:r>
              <a:rPr lang="en-AU" sz="1200" i="1" dirty="0">
                <a:latin typeface="Times New Roman" panose="02020603050405020304" pitchFamily="18" charset="0"/>
                <a:ea typeface="MS Mincho"/>
              </a:rPr>
              <a:t>Dmp1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 mRNA expression. </a:t>
            </a:r>
            <a:r>
              <a:rPr lang="en-AU" sz="1200" dirty="0" smtClean="0">
                <a:latin typeface="Times New Roman" panose="02020603050405020304" pitchFamily="18" charset="0"/>
                <a:ea typeface="MS Mincho"/>
              </a:rPr>
              <a:t>IDG-SW3 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cells differentiated for 5 weeks were treated with A) rhPTH1-34 and B) rhSCL for 24 h at the concentrations indicated and </a:t>
            </a:r>
            <a:r>
              <a:rPr lang="en-AU" sz="1200" i="1" dirty="0">
                <a:latin typeface="Times New Roman" panose="02020603050405020304" pitchFamily="18" charset="0"/>
                <a:ea typeface="MS Mincho"/>
              </a:rPr>
              <a:t>Dmp1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 mRNA levels measured by real time RT-PCR. </a:t>
            </a:r>
            <a:r>
              <a:rPr lang="en-AU" sz="1200" i="1" dirty="0">
                <a:latin typeface="Times New Roman" panose="02020603050405020304" pitchFamily="18" charset="0"/>
                <a:ea typeface="MS Mincho"/>
              </a:rPr>
              <a:t>Dmp1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 mRNA levels were also measured in a time course in response to C) rhPTH1-34 (100 </a:t>
            </a:r>
            <a:r>
              <a:rPr lang="en-AU" sz="1200" dirty="0" err="1">
                <a:latin typeface="Times New Roman" panose="02020603050405020304" pitchFamily="18" charset="0"/>
                <a:ea typeface="MS Mincho"/>
              </a:rPr>
              <a:t>nM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), and D) rhSCL (50 ng/ml). Gene expression was normalised to </a:t>
            </a:r>
            <a:r>
              <a:rPr lang="en-AU" sz="1200" i="1" dirty="0" err="1">
                <a:latin typeface="Times New Roman" panose="02020603050405020304" pitchFamily="18" charset="0"/>
                <a:ea typeface="MS Mincho"/>
              </a:rPr>
              <a:t>Gapdh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 mRNA levels and data described as mean fold-change </a:t>
            </a:r>
            <a:r>
              <a:rPr lang="en-AU" sz="1200" dirty="0" smtClean="0">
                <a:latin typeface="Times New Roman" panose="02020603050405020304" pitchFamily="18" charset="0"/>
                <a:ea typeface="MS Mincho"/>
              </a:rPr>
              <a:t>± 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SEM relative to the untreated normal control (NC) or the time zero level. Significant difference to the reference level is depicted by * p&lt;0.05; ** p&lt;0.01; *** p&lt;0.001.</a:t>
            </a:r>
            <a:endParaRPr lang="en-AU" sz="1200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975" y="1176043"/>
            <a:ext cx="6139204" cy="4060288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81</TotalTime>
  <Words>12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MS Mincho</vt:lpstr>
      <vt:lpstr>Times New Roman</vt:lpstr>
      <vt:lpstr>Default Desig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rald Atkins</dc:creator>
  <cp:lastModifiedBy>Gerald Atkins</cp:lastModifiedBy>
  <cp:revision>371</cp:revision>
  <cp:lastPrinted>2018-05-24T08:03:24Z</cp:lastPrinted>
  <dcterms:created xsi:type="dcterms:W3CDTF">1601-01-01T00:00:00Z</dcterms:created>
  <dcterms:modified xsi:type="dcterms:W3CDTF">2020-10-29T23:54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